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60" r:id="rId5"/>
  </p:sldMasterIdLst>
  <p:notesMasterIdLst>
    <p:notesMasterId r:id="rId6"/>
  </p:notesMasterIdLst>
  <p:sldIdLst>
    <p:sldId id="256" r:id="rId7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D29DD9A9-9814-42EF-B3AD-B5BEFE3424DD}">
  <a:tblStyle styleId="{D29DD9A9-9814-42EF-B3AD-B5BEFE3424DD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394b685c08_0_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8" name="Google Shape;58;g1394b685c08_0_5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re et contenu" type="obj">
  <p:cSld name="OBJECT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/>
          <p:nvPr>
            <p:ph type="title"/>
          </p:nvPr>
        </p:nvSpPr>
        <p:spPr>
          <a:xfrm>
            <a:off x="628650" y="273844"/>
            <a:ext cx="7886700" cy="9942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lv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" type="body"/>
          </p:nvPr>
        </p:nvSpPr>
        <p:spPr>
          <a:xfrm>
            <a:off x="628650" y="1369219"/>
            <a:ext cx="7886700" cy="32634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/>
          </a:bodyPr>
          <a:lstStyle>
            <a:lvl1pPr indent="-317500" lvl="0" marL="457200" rtl="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1pPr>
            <a:lvl2pPr indent="-317500" lvl="1" marL="914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2pPr>
            <a:lvl3pPr indent="-317500" lvl="2" marL="1371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3pPr>
            <a:lvl4pPr indent="-317500" lvl="3" marL="18288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4pPr>
            <a:lvl5pPr indent="-317500" lvl="4" marL="22860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5pPr>
            <a:lvl6pPr indent="-317500" lvl="5" marL="27432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6pPr>
            <a:lvl7pPr indent="-317500" lvl="6" marL="3200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7pPr>
            <a:lvl8pPr indent="-317500" lvl="7" marL="3657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8pPr>
            <a:lvl9pPr indent="-317500" lvl="8" marL="4114800" rtl="0" algn="l">
              <a:lnSpc>
                <a:spcPct val="90000"/>
              </a:lnSpc>
              <a:spcBef>
                <a:spcPts val="1200"/>
              </a:spcBef>
              <a:spcAft>
                <a:spcPts val="1200"/>
              </a:spcAft>
              <a:buClr>
                <a:schemeClr val="dk1"/>
              </a:buClr>
              <a:buSzPts val="1400"/>
              <a:buChar char="■"/>
              <a:defRPr/>
            </a:lvl9pPr>
          </a:lstStyle>
          <a:p/>
        </p:txBody>
      </p:sp>
      <p:sp>
        <p:nvSpPr>
          <p:cNvPr id="53" name="Google Shape;53;p13"/>
          <p:cNvSpPr txBox="1"/>
          <p:nvPr>
            <p:ph idx="10" type="dt"/>
          </p:nvPr>
        </p:nvSpPr>
        <p:spPr>
          <a:xfrm>
            <a:off x="6286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4" name="Google Shape;54;p13"/>
          <p:cNvSpPr txBox="1"/>
          <p:nvPr>
            <p:ph idx="11" type="ftr"/>
          </p:nvPr>
        </p:nvSpPr>
        <p:spPr>
          <a:xfrm>
            <a:off x="3028950" y="4767263"/>
            <a:ext cx="30861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5" name="Google Shape;55;p13"/>
          <p:cNvSpPr txBox="1"/>
          <p:nvPr>
            <p:ph idx="12" type="sldNum"/>
          </p:nvPr>
        </p:nvSpPr>
        <p:spPr>
          <a:xfrm>
            <a:off x="64579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indent="0" lvl="0" marL="0" rtl="0" algn="r">
              <a:spcBef>
                <a:spcPts val="0"/>
              </a:spcBef>
              <a:buNone/>
              <a:defRPr/>
            </a:lvl1pPr>
            <a:lvl2pPr indent="0" lvl="1" marL="0" rtl="0" algn="r">
              <a:spcBef>
                <a:spcPts val="0"/>
              </a:spcBef>
              <a:buNone/>
              <a:defRPr/>
            </a:lvl2pPr>
            <a:lvl3pPr indent="0" lvl="2" marL="0" rtl="0" algn="r">
              <a:spcBef>
                <a:spcPts val="0"/>
              </a:spcBef>
              <a:buNone/>
              <a:defRPr/>
            </a:lvl3pPr>
            <a:lvl4pPr indent="0" lvl="3" marL="0" rtl="0" algn="r">
              <a:spcBef>
                <a:spcPts val="0"/>
              </a:spcBef>
              <a:buNone/>
              <a:defRPr/>
            </a:lvl4pPr>
            <a:lvl5pPr indent="0" lvl="4" marL="0" rtl="0" algn="r">
              <a:spcBef>
                <a:spcPts val="0"/>
              </a:spcBef>
              <a:buNone/>
              <a:defRPr/>
            </a:lvl5pPr>
            <a:lvl6pPr indent="0" lvl="5" marL="0" rtl="0" algn="r">
              <a:spcBef>
                <a:spcPts val="0"/>
              </a:spcBef>
              <a:buNone/>
              <a:defRPr/>
            </a:lvl6pPr>
            <a:lvl7pPr indent="0" lvl="6" marL="0" rtl="0" algn="r">
              <a:spcBef>
                <a:spcPts val="0"/>
              </a:spcBef>
              <a:buNone/>
              <a:defRPr/>
            </a:lvl7pPr>
            <a:lvl8pPr indent="0" lvl="7" marL="0" rtl="0" algn="r">
              <a:spcBef>
                <a:spcPts val="0"/>
              </a:spcBef>
              <a:buNone/>
              <a:defRPr/>
            </a:lvl8pPr>
            <a:lvl9pPr indent="0" lvl="8" marL="0" rt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theme" Target="../theme/theme2.xml"/><Relationship Id="rId12" Type="http://schemas.openxmlformats.org/officeDocument/2006/relationships/slideLayout" Target="../slideLayouts/slideLayout12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Google Shape;60;p14"/>
          <p:cNvGraphicFramePr/>
          <p:nvPr/>
        </p:nvGraphicFramePr>
        <p:xfrm>
          <a:off x="189532" y="120610"/>
          <a:ext cx="3000000" cy="3000000"/>
        </p:xfrm>
        <a:graphic>
          <a:graphicData uri="http://schemas.openxmlformats.org/drawingml/2006/table">
            <a:tbl>
              <a:tblPr>
                <a:noFill/>
                <a:tableStyleId>{D29DD9A9-9814-42EF-B3AD-B5BEFE3424DD}</a:tableStyleId>
              </a:tblPr>
              <a:tblGrid>
                <a:gridCol w="847800"/>
                <a:gridCol w="693500"/>
                <a:gridCol w="874250"/>
                <a:gridCol w="861250"/>
                <a:gridCol w="955450"/>
              </a:tblGrid>
              <a:tr h="261175">
                <a:tc gridSpan="5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fr" sz="1400" u="none" cap="none" strike="noStrike">
                          <a:solidFill>
                            <a:schemeClr val="lt1"/>
                          </a:solidFill>
                        </a:rPr>
                        <a:t>Alpha diversity</a:t>
                      </a:r>
                      <a:endParaRPr b="1" sz="1400" u="none" cap="none" strike="noStrike">
                        <a:solidFill>
                          <a:schemeClr val="lt1"/>
                        </a:solidFill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4285F4"/>
                    </a:solidFill>
                  </a:tcPr>
                </a:tc>
                <a:tc hMerge="1"/>
                <a:tc hMerge="1"/>
                <a:tc hMerge="1"/>
                <a:tc hMerge="1"/>
              </a:tr>
              <a:tr h="3798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Test</a:t>
                      </a:r>
                      <a:endParaRPr sz="1400" u="none" cap="none" strike="noStrike">
                        <a:solidFill>
                          <a:schemeClr val="dk1"/>
                        </a:solidFill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Variable</a:t>
                      </a:r>
                      <a:endParaRPr sz="1400" u="none" cap="none" strike="noStrike">
                        <a:solidFill>
                          <a:schemeClr val="dk1"/>
                        </a:solidFill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Inverse Simpson</a:t>
                      </a:r>
                      <a:endParaRPr sz="1400" u="none" cap="none" strike="noStrike">
                        <a:solidFill>
                          <a:schemeClr val="dk1"/>
                        </a:solidFill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Shannon</a:t>
                      </a:r>
                      <a:endParaRPr sz="1400" u="none" cap="none" strike="noStrike">
                        <a:solidFill>
                          <a:schemeClr val="dk1"/>
                        </a:solidFill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Observed</a:t>
                      </a:r>
                      <a:endParaRPr sz="1400" u="none" cap="none" strike="noStrike">
                        <a:solidFill>
                          <a:schemeClr val="dk1"/>
                        </a:solidFill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13675">
                <a:tc rowSpan="2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Pairwise Wilcoxon rank sum test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roup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2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2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2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4985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ender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49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8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9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37425">
                <a:tc rowSpan="8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Spearman's rank correlation test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MI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46</a:t>
                      </a:r>
                      <a:r>
                        <a:rPr b="1" i="0" lang="fr" sz="15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*</a:t>
                      </a:r>
                      <a:endParaRPr b="1" sz="18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9900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5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13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3742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1683705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16017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126017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136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roup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228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2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285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136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975792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9728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8675851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3798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ender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40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821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3798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724629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336853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1978574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136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Ag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44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21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58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3798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417022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446455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497294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61" name="Google Shape;61;p14"/>
          <p:cNvGraphicFramePr/>
          <p:nvPr/>
        </p:nvGraphicFramePr>
        <p:xfrm>
          <a:off x="4715960" y="2649608"/>
          <a:ext cx="3000000" cy="3000000"/>
        </p:xfrm>
        <a:graphic>
          <a:graphicData uri="http://schemas.openxmlformats.org/drawingml/2006/table">
            <a:tbl>
              <a:tblPr>
                <a:noFill/>
                <a:tableStyleId>{D29DD9A9-9814-42EF-B3AD-B5BEFE3424DD}</a:tableStyleId>
              </a:tblPr>
              <a:tblGrid>
                <a:gridCol w="1417325"/>
                <a:gridCol w="708650"/>
                <a:gridCol w="708650"/>
              </a:tblGrid>
              <a:tr h="212650">
                <a:tc gridSpan="3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FFFFFF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eta diversity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4285F4"/>
                    </a:solidFill>
                  </a:tcPr>
                </a:tc>
                <a:tc hMerge="1"/>
                <a:tc hMerge="1"/>
              </a:tr>
              <a:tr h="2126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Variabl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p-valu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²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126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roup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116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0874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126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ender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546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080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126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Ag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886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908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126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MI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9874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929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</a:tbl>
          </a:graphicData>
        </a:graphic>
      </p:graphicFrame>
      <p:pic>
        <p:nvPicPr>
          <p:cNvPr descr="https://lh5.googleusercontent.com/ZkJxBwtswFtRZHa3IxQ9FQeaT9Dx5_CPZguEbRwpO9ZQtibbOSXzeZI2iwdVEsW7W01zqPsQ_isbg-EWsFN6cdq5WLh9xQWD_xpks590FqvLDUBkcq-XdlE4geYEFZsF4rRxP5A6R2louPMHBl99Y7JfxvYiIDL-HtNquGKWNdyPA0yPonnViYfBg4-f" id="62" name="Google Shape;62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715954" y="44410"/>
            <a:ext cx="2546734" cy="2604071"/>
          </a:xfrm>
          <a:prstGeom prst="rect">
            <a:avLst/>
          </a:prstGeom>
          <a:noFill/>
          <a:ln>
            <a:noFill/>
          </a:ln>
        </p:spPr>
      </p:pic>
      <p:sp>
        <p:nvSpPr>
          <p:cNvPr id="63" name="Google Shape;63;p14"/>
          <p:cNvSpPr txBox="1"/>
          <p:nvPr/>
        </p:nvSpPr>
        <p:spPr>
          <a:xfrm>
            <a:off x="-11069" y="109108"/>
            <a:ext cx="2022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4" name="Google Shape;64;p14"/>
          <p:cNvSpPr txBox="1"/>
          <p:nvPr/>
        </p:nvSpPr>
        <p:spPr>
          <a:xfrm>
            <a:off x="4467753" y="2571758"/>
            <a:ext cx="2022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5" name="Google Shape;65;p14"/>
          <p:cNvSpPr txBox="1"/>
          <p:nvPr/>
        </p:nvSpPr>
        <p:spPr>
          <a:xfrm>
            <a:off x="4428456" y="105062"/>
            <a:ext cx="2022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6" name="Google Shape;66;p14"/>
          <p:cNvSpPr txBox="1"/>
          <p:nvPr/>
        </p:nvSpPr>
        <p:spPr>
          <a:xfrm>
            <a:off x="2597100" y="3929542"/>
            <a:ext cx="3864900" cy="10479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 lnSpcReduction="10000"/>
          </a:bodyPr>
          <a:lstStyle/>
          <a:p>
            <a:pPr indent="-184150" lvl="0" marL="177800" marR="0" rtl="0" algn="just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•"/>
            </a:pP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Statistical analysis result obtained using CRISPR approach. [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A] 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Alpha diversity results using Pairwise Wilcoxon rank sum test and Spearman’s rank correlation test. 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[B] 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Alpha diversity measure plot for each indices for control (C) and Parkinson (P) groups. 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[C] </a:t>
            </a:r>
            <a:r>
              <a:rPr lang="fr" sz="11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Beta diversity results obtained using Jaccard distance in univariable PERMANOVA models. </a:t>
            </a:r>
            <a:endParaRPr sz="1100">
              <a:solidFill>
                <a:srgbClr val="000000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